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1744D-D44E-41C1-938D-FF214095D27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394C4-7AD3-4B73-B64B-B98BF03986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EE511-76ED-4B6C-B900-CA3D16D4DD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933217-064B-48EC-BAB4-8C23F554D0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EF7043-981C-4030-842C-BFC60B0DD1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86524-4EDE-4F9A-8F03-8988076DDB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88E93-B459-422B-A571-3F3D29B0BB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35C139-55A0-4FCA-B63E-08C9C628BE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9E251-C58B-43B1-A401-D735629776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4919B7-6F51-4350-B64D-3EEA52FB4A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93B8F-CA5C-4B94-98FC-064DD1632C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D4744F-6AF1-4510-BBE0-2D1FE5047B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AB43C2-84C8-455B-A102-1783CDF0A799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299880" y="836640"/>
            <a:ext cx="3840480" cy="24033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tretch/>
        </p:blipFill>
        <p:spPr>
          <a:xfrm>
            <a:off x="4500720" y="947880"/>
            <a:ext cx="3887640" cy="2336760"/>
          </a:xfrm>
          <a:prstGeom prst="rect">
            <a:avLst/>
          </a:prstGeom>
          <a:ln w="0">
            <a:noFill/>
          </a:ln>
        </p:spPr>
      </p:pic>
      <p:sp>
        <p:nvSpPr>
          <p:cNvPr id="43" name="テキスト ボックス 5"/>
          <p:cNvSpPr/>
          <p:nvPr/>
        </p:nvSpPr>
        <p:spPr>
          <a:xfrm>
            <a:off x="284760" y="4129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5"/>
          <p:cNvSpPr/>
          <p:nvPr/>
        </p:nvSpPr>
        <p:spPr>
          <a:xfrm>
            <a:off x="4502520" y="29376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正方形/長方形 88"/>
          <p:cNvSpPr/>
          <p:nvPr/>
        </p:nvSpPr>
        <p:spPr>
          <a:xfrm rot="16200000">
            <a:off x="-104400" y="1395360"/>
            <a:ext cx="70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ell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正方形/長方形 89"/>
          <p:cNvSpPr/>
          <p:nvPr/>
        </p:nvSpPr>
        <p:spPr>
          <a:xfrm rot="16200000">
            <a:off x="4152960" y="1537920"/>
            <a:ext cx="70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ell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角丸四角形 22"/>
          <p:cNvSpPr/>
          <p:nvPr/>
        </p:nvSpPr>
        <p:spPr>
          <a:xfrm>
            <a:off x="900000" y="1413000"/>
            <a:ext cx="576360" cy="1017360"/>
          </a:xfrm>
          <a:custGeom>
            <a:avLst/>
            <a:gdLst>
              <a:gd name="textAreaLeft" fmla="*/ 28080 w 576360"/>
              <a:gd name="textAreaRight" fmla="*/ 548280 w 576360"/>
              <a:gd name="textAreaTop" fmla="*/ 28080 h 1017360"/>
              <a:gd name="textAreaBottom" fmla="*/ 989280 h 1017360"/>
            </a:gdLst>
            <a:ahLst/>
            <a:rect l="textAreaLeft" t="textAreaTop" r="textAreaRight" b="textAreaBottom"/>
            <a:pathLst>
              <a:path w="21600" h="38117">
                <a:moveTo>
                  <a:pt x="3600" y="0"/>
                </a:moveTo>
                <a:arcTo wR="3600" hR="3600" stAng="16200000" swAng="-5400000"/>
                <a:lnTo>
                  <a:pt x="0" y="34517"/>
                </a:lnTo>
                <a:arcTo wR="3600" hR="3600" stAng="10800000" swAng="-5400000"/>
                <a:lnTo>
                  <a:pt x="18000" y="38117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角丸四角形 23"/>
          <p:cNvSpPr/>
          <p:nvPr/>
        </p:nvSpPr>
        <p:spPr>
          <a:xfrm>
            <a:off x="1494000" y="1125360"/>
            <a:ext cx="774360" cy="1295640"/>
          </a:xfrm>
          <a:custGeom>
            <a:avLst/>
            <a:gdLst>
              <a:gd name="textAreaLeft" fmla="*/ 37800 w 774360"/>
              <a:gd name="textAreaRight" fmla="*/ 736560 w 774360"/>
              <a:gd name="textAreaTop" fmla="*/ 37800 h 1295640"/>
              <a:gd name="textAreaBottom" fmla="*/ 1257840 h 1295640"/>
            </a:gdLst>
            <a:ahLst/>
            <a:rect l="textAreaLeft" t="textAreaTop" r="textAreaRight" b="textAreaBottom"/>
            <a:pathLst>
              <a:path w="21600" h="36134">
                <a:moveTo>
                  <a:pt x="3600" y="0"/>
                </a:moveTo>
                <a:arcTo wR="3600" hR="3600" stAng="16200000" swAng="-5400000"/>
                <a:lnTo>
                  <a:pt x="0" y="32534"/>
                </a:lnTo>
                <a:arcTo wR="3600" hR="3600" stAng="10800000" swAng="-5400000"/>
                <a:lnTo>
                  <a:pt x="18000" y="36134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角丸四角形 24"/>
          <p:cNvSpPr/>
          <p:nvPr/>
        </p:nvSpPr>
        <p:spPr>
          <a:xfrm>
            <a:off x="2286000" y="1711440"/>
            <a:ext cx="863640" cy="71748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角丸四角形 25"/>
          <p:cNvSpPr/>
          <p:nvPr/>
        </p:nvSpPr>
        <p:spPr>
          <a:xfrm>
            <a:off x="3149640" y="1494000"/>
            <a:ext cx="863640" cy="934920"/>
          </a:xfrm>
          <a:custGeom>
            <a:avLst/>
            <a:gdLst>
              <a:gd name="textAreaLeft" fmla="*/ 42120 w 863640"/>
              <a:gd name="textAreaRight" fmla="*/ 821520 w 863640"/>
              <a:gd name="textAreaTop" fmla="*/ 42120 h 934920"/>
              <a:gd name="textAreaBottom" fmla="*/ 892800 h 934920"/>
            </a:gdLst>
            <a:ahLst/>
            <a:rect l="textAreaLeft" t="textAreaTop" r="textAreaRight" b="textAreaBottom"/>
            <a:pathLst>
              <a:path w="21600" h="23382">
                <a:moveTo>
                  <a:pt x="3600" y="0"/>
                </a:moveTo>
                <a:arcTo wR="3600" hR="3600" stAng="16200000" swAng="-5400000"/>
                <a:lnTo>
                  <a:pt x="0" y="19782"/>
                </a:lnTo>
                <a:arcTo wR="3600" hR="3600" stAng="10800000" swAng="-5400000"/>
                <a:lnTo>
                  <a:pt x="18000" y="23382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正方形/長方形 7"/>
          <p:cNvSpPr/>
          <p:nvPr/>
        </p:nvSpPr>
        <p:spPr>
          <a:xfrm>
            <a:off x="937440" y="1198440"/>
            <a:ext cx="52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PI3K 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正方形/長方形 8"/>
          <p:cNvSpPr/>
          <p:nvPr/>
        </p:nvSpPr>
        <p:spPr>
          <a:xfrm>
            <a:off x="1585800" y="880920"/>
            <a:ext cx="62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MAPK 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正方形/長方形 9"/>
          <p:cNvSpPr/>
          <p:nvPr/>
        </p:nvSpPr>
        <p:spPr>
          <a:xfrm>
            <a:off x="2410560" y="146052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Combo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正方形/長方形 10"/>
          <p:cNvSpPr/>
          <p:nvPr/>
        </p:nvSpPr>
        <p:spPr>
          <a:xfrm>
            <a:off x="3240720" y="124632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Combo-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正方形/長方形 7"/>
          <p:cNvSpPr/>
          <p:nvPr/>
        </p:nvSpPr>
        <p:spPr>
          <a:xfrm>
            <a:off x="5152320" y="1014480"/>
            <a:ext cx="52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PI3K 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正方形/長方形 8"/>
          <p:cNvSpPr/>
          <p:nvPr/>
        </p:nvSpPr>
        <p:spPr>
          <a:xfrm>
            <a:off x="5800680" y="1014480"/>
            <a:ext cx="62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MAPK 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正方形/長方形 9"/>
          <p:cNvSpPr/>
          <p:nvPr/>
        </p:nvSpPr>
        <p:spPr>
          <a:xfrm>
            <a:off x="6653880" y="141768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Combo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正方形/長方形 10"/>
          <p:cNvSpPr/>
          <p:nvPr/>
        </p:nvSpPr>
        <p:spPr>
          <a:xfrm>
            <a:off x="7484400" y="123048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Combo-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角丸四角形 49"/>
          <p:cNvSpPr/>
          <p:nvPr/>
        </p:nvSpPr>
        <p:spPr>
          <a:xfrm>
            <a:off x="5148360" y="1370160"/>
            <a:ext cx="576000" cy="1019160"/>
          </a:xfrm>
          <a:custGeom>
            <a:avLst/>
            <a:gdLst>
              <a:gd name="textAreaLeft" fmla="*/ 28080 w 576000"/>
              <a:gd name="textAreaRight" fmla="*/ 547920 w 576000"/>
              <a:gd name="textAreaTop" fmla="*/ 28080 h 1019160"/>
              <a:gd name="textAreaBottom" fmla="*/ 991080 h 1019160"/>
            </a:gdLst>
            <a:ahLst/>
            <a:rect l="textAreaLeft" t="textAreaTop" r="textAreaRight" b="textAreaBottom"/>
            <a:pathLst>
              <a:path w="21600" h="38208">
                <a:moveTo>
                  <a:pt x="3600" y="0"/>
                </a:moveTo>
                <a:arcTo wR="3600" hR="3600" stAng="16200000" swAng="-5400000"/>
                <a:lnTo>
                  <a:pt x="0" y="34608"/>
                </a:lnTo>
                <a:arcTo wR="3600" hR="3600" stAng="10800000" swAng="-5400000"/>
                <a:lnTo>
                  <a:pt x="18000" y="38208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角丸四角形 50"/>
          <p:cNvSpPr/>
          <p:nvPr/>
        </p:nvSpPr>
        <p:spPr>
          <a:xfrm>
            <a:off x="5742000" y="1236600"/>
            <a:ext cx="774720" cy="1143000"/>
          </a:xfrm>
          <a:custGeom>
            <a:avLst/>
            <a:gdLst>
              <a:gd name="textAreaLeft" fmla="*/ 37800 w 774720"/>
              <a:gd name="textAreaRight" fmla="*/ 736920 w 774720"/>
              <a:gd name="textAreaTop" fmla="*/ 37800 h 1143000"/>
              <a:gd name="textAreaBottom" fmla="*/ 1105200 h 1143000"/>
            </a:gdLst>
            <a:ahLst/>
            <a:rect l="textAreaLeft" t="textAreaTop" r="textAreaRight" b="textAreaBottom"/>
            <a:pathLst>
              <a:path w="21600" h="31863">
                <a:moveTo>
                  <a:pt x="3600" y="0"/>
                </a:moveTo>
                <a:arcTo wR="3600" hR="3600" stAng="16200000" swAng="-5400000"/>
                <a:lnTo>
                  <a:pt x="0" y="28263"/>
                </a:lnTo>
                <a:arcTo wR="3600" hR="3600" stAng="10800000" swAng="-5400000"/>
                <a:lnTo>
                  <a:pt x="18000" y="31863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角丸四角形 51"/>
          <p:cNvSpPr/>
          <p:nvPr/>
        </p:nvSpPr>
        <p:spPr>
          <a:xfrm>
            <a:off x="6534000" y="1668600"/>
            <a:ext cx="863640" cy="71892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角丸四角形 52"/>
          <p:cNvSpPr/>
          <p:nvPr/>
        </p:nvSpPr>
        <p:spPr>
          <a:xfrm>
            <a:off x="7397640" y="1452600"/>
            <a:ext cx="863640" cy="934920"/>
          </a:xfrm>
          <a:custGeom>
            <a:avLst/>
            <a:gdLst>
              <a:gd name="textAreaLeft" fmla="*/ 42120 w 863640"/>
              <a:gd name="textAreaRight" fmla="*/ 821520 w 863640"/>
              <a:gd name="textAreaTop" fmla="*/ 42120 h 934920"/>
              <a:gd name="textAreaBottom" fmla="*/ 892800 h 934920"/>
            </a:gdLst>
            <a:ahLst/>
            <a:rect l="textAreaLeft" t="textAreaTop" r="textAreaRight" b="textAreaBottom"/>
            <a:pathLst>
              <a:path w="21600" h="23382">
                <a:moveTo>
                  <a:pt x="3600" y="0"/>
                </a:moveTo>
                <a:arcTo wR="3600" hR="3600" stAng="16200000" swAng="-5400000"/>
                <a:lnTo>
                  <a:pt x="0" y="19782"/>
                </a:lnTo>
                <a:arcTo wR="3600" hR="3600" stAng="10800000" swAng="-5400000"/>
                <a:lnTo>
                  <a:pt x="18000" y="23382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63"/>
          <p:cNvSpPr/>
          <p:nvPr/>
        </p:nvSpPr>
        <p:spPr>
          <a:xfrm>
            <a:off x="7768800" y="-9360"/>
            <a:ext cx="133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hoji K; Figure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正方形/長方形 11"/>
          <p:cNvSpPr/>
          <p:nvPr/>
        </p:nvSpPr>
        <p:spPr>
          <a:xfrm>
            <a:off x="971640" y="422280"/>
            <a:ext cx="2665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HHUA (Group C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正方形/長方形 11"/>
          <p:cNvSpPr/>
          <p:nvPr/>
        </p:nvSpPr>
        <p:spPr>
          <a:xfrm>
            <a:off x="4932360" y="384120"/>
            <a:ext cx="266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KLE (Group D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テキスト ボックス 23"/>
          <p:cNvSpPr/>
          <p:nvPr/>
        </p:nvSpPr>
        <p:spPr>
          <a:xfrm>
            <a:off x="194400" y="343044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グラフ 54" descr=""/>
          <p:cNvPicPr/>
          <p:nvPr/>
        </p:nvPicPr>
        <p:blipFill>
          <a:blip r:embed="rId3"/>
          <a:stretch/>
        </p:blipFill>
        <p:spPr>
          <a:xfrm>
            <a:off x="317520" y="3713040"/>
            <a:ext cx="4114800" cy="2816280"/>
          </a:xfrm>
          <a:prstGeom prst="rect">
            <a:avLst/>
          </a:prstGeom>
          <a:ln w="0">
            <a:noFill/>
          </a:ln>
        </p:spPr>
      </p:pic>
      <p:sp>
        <p:nvSpPr>
          <p:cNvPr id="68" name="Rectangle 63"/>
          <p:cNvSpPr/>
          <p:nvPr/>
        </p:nvSpPr>
        <p:spPr>
          <a:xfrm rot="16200000">
            <a:off x="-153360" y="4654440"/>
            <a:ext cx="82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0/G1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正方形/長方形 56"/>
          <p:cNvSpPr/>
          <p:nvPr/>
        </p:nvSpPr>
        <p:spPr>
          <a:xfrm>
            <a:off x="2057400" y="3357720"/>
            <a:ext cx="120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HUA (Group 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テキスト ボックス 5"/>
          <p:cNvSpPr/>
          <p:nvPr/>
        </p:nvSpPr>
        <p:spPr>
          <a:xfrm>
            <a:off x="4357440" y="350028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正方形/長方形 58"/>
          <p:cNvSpPr/>
          <p:nvPr/>
        </p:nvSpPr>
        <p:spPr>
          <a:xfrm>
            <a:off x="6143760" y="3567240"/>
            <a:ext cx="106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KLE (Group 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" name="グラフ 59" descr=""/>
          <p:cNvPicPr/>
          <p:nvPr/>
        </p:nvPicPr>
        <p:blipFill>
          <a:blip r:embed="rId4"/>
          <a:stretch/>
        </p:blipFill>
        <p:spPr>
          <a:xfrm>
            <a:off x="4492800" y="3852720"/>
            <a:ext cx="4187520" cy="2676600"/>
          </a:xfrm>
          <a:prstGeom prst="rect">
            <a:avLst/>
          </a:prstGeom>
          <a:ln w="0">
            <a:noFill/>
          </a:ln>
        </p:spPr>
      </p:pic>
      <p:sp>
        <p:nvSpPr>
          <p:cNvPr id="73" name="Rectangle 63"/>
          <p:cNvSpPr/>
          <p:nvPr/>
        </p:nvSpPr>
        <p:spPr>
          <a:xfrm rot="16200000">
            <a:off x="4011840" y="4524120"/>
            <a:ext cx="82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0/G1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30T15:53:26Z</dcterms:created>
  <dc:creator>Katsutoshi</dc:creator>
  <dc:description/>
  <dc:language>en-US</dc:language>
  <cp:lastModifiedBy>ODA Family</cp:lastModifiedBy>
  <dcterms:modified xsi:type="dcterms:W3CDTF">2012-04-27T14:58:24Z</dcterms:modified>
  <cp:revision>13</cp:revision>
  <dc:subject/>
  <dc:title>PowerPoint プレゼンテーション</dc:title>
</cp:coreProperties>
</file>